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5" r:id="rId2"/>
    <p:sldId id="321" r:id="rId3"/>
    <p:sldId id="337" r:id="rId4"/>
    <p:sldId id="338" r:id="rId5"/>
    <p:sldId id="306" r:id="rId6"/>
    <p:sldId id="339" r:id="rId7"/>
    <p:sldId id="341" r:id="rId8"/>
    <p:sldId id="342" r:id="rId9"/>
    <p:sldId id="340" r:id="rId10"/>
    <p:sldId id="343" r:id="rId11"/>
    <p:sldId id="345" r:id="rId12"/>
    <p:sldId id="346" r:id="rId13"/>
    <p:sldId id="344" r:id="rId14"/>
    <p:sldId id="336" r:id="rId15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35" autoAdjust="0"/>
    <p:restoredTop sz="94660"/>
  </p:normalViewPr>
  <p:slideViewPr>
    <p:cSldViewPr snapToGrid="0">
      <p:cViewPr>
        <p:scale>
          <a:sx n="66" d="100"/>
          <a:sy n="66" d="100"/>
        </p:scale>
        <p:origin x="1338" y="11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237BD0-F5AB-4FA3-A88B-62BD44F2D3A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8D6C242F-D872-410C-B6B3-5655A7CBED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F728FB3-2379-45FF-B5EA-F05728037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35346BC-29FA-42EA-9D17-C1D71F7F13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0573DD6-CD3A-4E49-B970-A0611773C0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823451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F2DA462-5452-4C91-9957-16DDF6979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DB1D522-00D8-44B5-87D6-CAADB89208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6E0E7BE-57AD-4DE2-97A0-1C394DF1D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B4DFA00-3A42-4171-8EA8-3022F193F1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72FF0FB-BB92-4BFD-AACF-9B5935DB67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629866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1749514-1483-4340-AA43-E2FCC2BF925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4AE4557-C1D8-42E1-B402-18D6AA0DAB5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E7C3C71-5A97-4DE6-A657-1455CC534E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6F33700-C254-4370-9AB0-06DAB59696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CE0F065-B8B8-4AB8-985A-6BB537E2AD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05008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B8AA4C86-C639-430D-9D78-7CBF05A8E4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6C2FB23-BC29-4584-AE24-1D1E0E0A69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B2E5B7DE-543E-48CC-8CAB-4BE2C1984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6ACDDF2-4530-4428-A6B1-DE8F0F0C9A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219E9C7-F3BB-4BB7-B025-905F7AB295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42595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519586FA-CF89-49F4-98BE-C6FCA7387E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CE759E7C-89CF-4208-BA19-B5E8B758BF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5BB48EA-9472-423E-A540-D48DBC18D0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86914A96-31E8-497E-BF36-E7A4756DD4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74D9ED47-930E-45BA-9BBF-5A02EAD631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590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24C8565-7D13-4141-8D6F-3B460F064B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2638AC50-D36D-43F6-9B1E-F7C035BD274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7A0068D2-F48C-4CB1-A6BC-73C7E265DBD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7FE8DA3-8FF2-4C84-861D-A6449DCAC3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779A3CEB-4214-4A25-A0A3-8AD2820413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8BC49DD-53AC-408D-AAA2-11773F42D9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56025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2C6F780-CD28-4251-8F0D-3EB92348E4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9B48CCC-3902-463A-90B1-7D9ECBE0C3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8CF3E4C5-44D7-481C-9965-5D8CDA92DDE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2891F301-43AD-4FEC-987D-7A75514DAD7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348EC588-E91C-4B8D-B773-74460516614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8B0729A4-9563-4769-B480-64DFDD920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F3F2F77C-60E2-4652-99C4-BC24F9880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7D8E7ECF-A482-4032-A09A-E9B6183ED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734187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A6AE73-1B1A-463A-893C-52F0A6C999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86A5B16-1E25-4286-ABE1-B7C92B3A69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8EE595FA-CB41-4BB2-98AA-6898CDFF3C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512EDF8C-9462-454F-BB51-4B3F281E3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9231086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99C565AD-B3C1-4CDA-9CED-F634CF42FD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C9630B9-47C7-440F-870F-F480B5069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29759782-61BC-4668-B57D-870FCA9559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16935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E5A944E-3D18-4495-839F-76083C23A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5EE9AF9-F9E7-4269-8B97-3AB6E9F8D6A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4D5DF36-33C6-4E21-BD94-27522A7B69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4AD2231-4111-4C03-A6B2-AF12818F63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680B77D-1451-4829-9C10-384BA8FF8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FA8DBDCD-AA38-4E91-B52E-9D83E4EC7A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546341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9DBA52D-E442-47A4-B61C-B131EDAD15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CE19019-B7D8-4D20-81D0-10F37247AC0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CDAF084A-3F04-4DE8-A3D8-450C0D6E66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E60BAA9-BF3D-487B-818D-F07AA2DF9A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D3C052D-CBE0-418F-9D6B-D043625CD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A567C98-99C7-41E1-AA85-A9D7E24624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780053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14C6FDAE-5BC7-4B94-B782-974BBEB03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D65F727-782C-4688-A546-0AB86232DB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FB3DD55-7C11-42CD-9EA9-5950123A4B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A8108A-3344-48AF-853B-AE8FBEF338EA}" type="datetimeFigureOut">
              <a:rPr lang="ko-KR" altLang="en-US" smtClean="0"/>
              <a:t>2023-02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FB70AC10-2246-4896-9571-75C428A981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CF03FA1-AC80-4F12-873C-68512C5CEF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5E7C9-2255-46D7-9A26-5F98A1DC8B2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800027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5" Type="http://schemas.microsoft.com/office/2007/relationships/hdphoto" Target="../media/hdphoto1.wdp"/><Relationship Id="rId4" Type="http://schemas.openxmlformats.org/officeDocument/2006/relationships/image" Target="../media/image21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그룹 48">
            <a:extLst>
              <a:ext uri="{FF2B5EF4-FFF2-40B4-BE49-F238E27FC236}">
                <a16:creationId xmlns:a16="http://schemas.microsoft.com/office/drawing/2014/main" id="{D8DD37EF-CBDE-D6AB-671A-D90D6A7A33CE}"/>
              </a:ext>
            </a:extLst>
          </p:cNvPr>
          <p:cNvGrpSpPr/>
          <p:nvPr/>
        </p:nvGrpSpPr>
        <p:grpSpPr>
          <a:xfrm>
            <a:off x="2346109" y="124873"/>
            <a:ext cx="7084228" cy="6545730"/>
            <a:chOff x="2346109" y="124873"/>
            <a:chExt cx="7084228" cy="6545730"/>
          </a:xfrm>
        </p:grpSpPr>
        <p:pic>
          <p:nvPicPr>
            <p:cNvPr id="46" name="그림 45">
              <a:extLst>
                <a:ext uri="{FF2B5EF4-FFF2-40B4-BE49-F238E27FC236}">
                  <a16:creationId xmlns:a16="http://schemas.microsoft.com/office/drawing/2014/main" id="{B889AD43-98B5-0144-D8A2-2951A5DEBE5F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244033" y="546027"/>
              <a:ext cx="1087794" cy="6123600"/>
            </a:xfrm>
            <a:prstGeom prst="rect">
              <a:avLst/>
            </a:prstGeom>
          </p:spPr>
        </p:pic>
        <p:pic>
          <p:nvPicPr>
            <p:cNvPr id="40" name="그림 39">
              <a:extLst>
                <a:ext uri="{FF2B5EF4-FFF2-40B4-BE49-F238E27FC236}">
                  <a16:creationId xmlns:a16="http://schemas.microsoft.com/office/drawing/2014/main" id="{0AE9E9AC-7F32-5ED4-9480-0D5497A103E6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012081" y="546027"/>
              <a:ext cx="1087794" cy="6123600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CAAA48A-385F-4133-958A-FB13CDC7293F}"/>
                </a:ext>
              </a:extLst>
            </p:cNvPr>
            <p:cNvSpPr txBox="1"/>
            <p:nvPr/>
          </p:nvSpPr>
          <p:spPr>
            <a:xfrm rot="16200000">
              <a:off x="-531513" y="3423650"/>
              <a:ext cx="6124575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EP@E14_E18_</a:t>
              </a:r>
              <a:r>
                <a:rPr lang="en-US" altLang="ko-KR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G-1</a:t>
              </a: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 / </a:t>
              </a:r>
              <a:r>
                <a:rPr lang="en-US" altLang="ko-KR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EEBBE1B3-7B55-4E28-BC6D-6DB74A8E6886}"/>
                </a:ext>
              </a:extLst>
            </p:cNvPr>
            <p:cNvCxnSpPr>
              <a:cxnSpLocks/>
            </p:cNvCxnSpPr>
            <p:nvPr/>
          </p:nvCxnSpPr>
          <p:spPr>
            <a:xfrm>
              <a:off x="2878462" y="703709"/>
              <a:ext cx="777600" cy="0"/>
            </a:xfrm>
            <a:prstGeom prst="line">
              <a:avLst/>
            </a:prstGeom>
            <a:ln w="28575">
              <a:solidFill>
                <a:schemeClr val="bg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681E88E-F666-42B8-B18B-7643A54F75B0}"/>
                </a:ext>
              </a:extLst>
            </p:cNvPr>
            <p:cNvSpPr txBox="1"/>
            <p:nvPr/>
          </p:nvSpPr>
          <p:spPr>
            <a:xfrm>
              <a:off x="2785703" y="128654"/>
              <a:ext cx="2160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rm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9562C8DA-6B16-4AFC-9F2D-83176DDD2FEB}"/>
                </a:ext>
              </a:extLst>
            </p:cNvPr>
            <p:cNvSpPr txBox="1"/>
            <p:nvPr/>
          </p:nvSpPr>
          <p:spPr>
            <a:xfrm>
              <a:off x="5007119" y="128654"/>
              <a:ext cx="2160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18KD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80036F5-F7C7-40F9-A9A3-B100F7922A5E}"/>
                </a:ext>
              </a:extLst>
            </p:cNvPr>
            <p:cNvSpPr txBox="1"/>
            <p:nvPr/>
          </p:nvSpPr>
          <p:spPr>
            <a:xfrm>
              <a:off x="7235960" y="124873"/>
              <a:ext cx="2160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rm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p27KD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그림 1">
              <a:extLst>
                <a:ext uri="{FF2B5EF4-FFF2-40B4-BE49-F238E27FC236}">
                  <a16:creationId xmlns:a16="http://schemas.microsoft.com/office/drawing/2014/main" id="{9C2112C8-A896-5C74-71ED-53470847F14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73284" y="546027"/>
              <a:ext cx="1087794" cy="6123600"/>
            </a:xfrm>
            <a:prstGeom prst="rect">
              <a:avLst/>
            </a:prstGeom>
          </p:spPr>
        </p:pic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30F438D6-C595-D890-9C97-6064A9E5E44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776758" y="546027"/>
              <a:ext cx="1087794" cy="6123600"/>
            </a:xfrm>
            <a:prstGeom prst="rect">
              <a:avLst/>
            </a:prstGeom>
          </p:spPr>
        </p:pic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7B29E91A-F86E-FCBB-A77D-76BB41D43180}"/>
                </a:ext>
              </a:extLst>
            </p:cNvPr>
            <p:cNvSpPr txBox="1"/>
            <p:nvPr/>
          </p:nvSpPr>
          <p:spPr>
            <a:xfrm>
              <a:off x="2762569" y="5161831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p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CBD43686-2EA5-1BEA-9A4C-F7B04E158C0C}"/>
                </a:ext>
              </a:extLst>
            </p:cNvPr>
            <p:cNvSpPr txBox="1"/>
            <p:nvPr/>
          </p:nvSpPr>
          <p:spPr>
            <a:xfrm>
              <a:off x="2762569" y="554546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4558C7C1-0066-8A3B-4C4C-AD50A3B097D7}"/>
                </a:ext>
              </a:extLst>
            </p:cNvPr>
            <p:cNvSpPr txBox="1"/>
            <p:nvPr/>
          </p:nvSpPr>
          <p:spPr>
            <a:xfrm>
              <a:off x="5017788" y="5032291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p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C29B244B-721D-01CF-A441-475CA9F45D33}"/>
                </a:ext>
              </a:extLst>
            </p:cNvPr>
            <p:cNvSpPr txBox="1"/>
            <p:nvPr/>
          </p:nvSpPr>
          <p:spPr>
            <a:xfrm>
              <a:off x="5017788" y="541592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그림 36">
              <a:extLst>
                <a:ext uri="{FF2B5EF4-FFF2-40B4-BE49-F238E27FC236}">
                  <a16:creationId xmlns:a16="http://schemas.microsoft.com/office/drawing/2014/main" id="{AE45D206-F44D-7650-F643-90027EE8B196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6104982" y="546027"/>
              <a:ext cx="1087794" cy="6123600"/>
            </a:xfrm>
            <a:prstGeom prst="rect">
              <a:avLst/>
            </a:prstGeom>
          </p:spPr>
        </p:pic>
        <p:sp>
          <p:nvSpPr>
            <p:cNvPr id="38" name="자유형: 도형 37">
              <a:extLst>
                <a:ext uri="{FF2B5EF4-FFF2-40B4-BE49-F238E27FC236}">
                  <a16:creationId xmlns:a16="http://schemas.microsoft.com/office/drawing/2014/main" id="{1F166A32-D628-B371-5037-4D012D1AB7FA}"/>
                </a:ext>
              </a:extLst>
            </p:cNvPr>
            <p:cNvSpPr/>
            <p:nvPr/>
          </p:nvSpPr>
          <p:spPr>
            <a:xfrm>
              <a:off x="5007119" y="5285714"/>
              <a:ext cx="1082040" cy="182880"/>
            </a:xfrm>
            <a:custGeom>
              <a:avLst/>
              <a:gdLst>
                <a:gd name="connsiteX0" fmla="*/ 0 w 1082040"/>
                <a:gd name="connsiteY0" fmla="*/ 182880 h 182880"/>
                <a:gd name="connsiteX1" fmla="*/ 68580 w 1082040"/>
                <a:gd name="connsiteY1" fmla="*/ 152400 h 182880"/>
                <a:gd name="connsiteX2" fmla="*/ 121920 w 1082040"/>
                <a:gd name="connsiteY2" fmla="*/ 121920 h 182880"/>
                <a:gd name="connsiteX3" fmla="*/ 190500 w 1082040"/>
                <a:gd name="connsiteY3" fmla="*/ 91440 h 182880"/>
                <a:gd name="connsiteX4" fmla="*/ 297180 w 1082040"/>
                <a:gd name="connsiteY4" fmla="*/ 60960 h 182880"/>
                <a:gd name="connsiteX5" fmla="*/ 320040 w 1082040"/>
                <a:gd name="connsiteY5" fmla="*/ 45720 h 182880"/>
                <a:gd name="connsiteX6" fmla="*/ 365760 w 1082040"/>
                <a:gd name="connsiteY6" fmla="*/ 38100 h 182880"/>
                <a:gd name="connsiteX7" fmla="*/ 502920 w 1082040"/>
                <a:gd name="connsiteY7" fmla="*/ 30480 h 182880"/>
                <a:gd name="connsiteX8" fmla="*/ 609600 w 1082040"/>
                <a:gd name="connsiteY8" fmla="*/ 15240 h 182880"/>
                <a:gd name="connsiteX9" fmla="*/ 784860 w 1082040"/>
                <a:gd name="connsiteY9" fmla="*/ 0 h 182880"/>
                <a:gd name="connsiteX10" fmla="*/ 1059180 w 1082040"/>
                <a:gd name="connsiteY10" fmla="*/ 7620 h 182880"/>
                <a:gd name="connsiteX11" fmla="*/ 1082040 w 1082040"/>
                <a:gd name="connsiteY11" fmla="*/ 15240 h 18288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1082040" h="182880">
                  <a:moveTo>
                    <a:pt x="0" y="182880"/>
                  </a:moveTo>
                  <a:cubicBezTo>
                    <a:pt x="136272" y="101117"/>
                    <a:pt x="-39336" y="201453"/>
                    <a:pt x="68580" y="152400"/>
                  </a:cubicBezTo>
                  <a:cubicBezTo>
                    <a:pt x="87223" y="143926"/>
                    <a:pt x="103942" y="131726"/>
                    <a:pt x="121920" y="121920"/>
                  </a:cubicBezTo>
                  <a:cubicBezTo>
                    <a:pt x="140265" y="111913"/>
                    <a:pt x="171197" y="97231"/>
                    <a:pt x="190500" y="91440"/>
                  </a:cubicBezTo>
                  <a:cubicBezTo>
                    <a:pt x="229550" y="79725"/>
                    <a:pt x="258506" y="86742"/>
                    <a:pt x="297180" y="60960"/>
                  </a:cubicBezTo>
                  <a:cubicBezTo>
                    <a:pt x="304800" y="55880"/>
                    <a:pt x="311352" y="48616"/>
                    <a:pt x="320040" y="45720"/>
                  </a:cubicBezTo>
                  <a:cubicBezTo>
                    <a:pt x="334697" y="40834"/>
                    <a:pt x="350363" y="39383"/>
                    <a:pt x="365760" y="38100"/>
                  </a:cubicBezTo>
                  <a:cubicBezTo>
                    <a:pt x="411392" y="34297"/>
                    <a:pt x="457200" y="33020"/>
                    <a:pt x="502920" y="30480"/>
                  </a:cubicBezTo>
                  <a:cubicBezTo>
                    <a:pt x="538480" y="25400"/>
                    <a:pt x="573836" y="18593"/>
                    <a:pt x="609600" y="15240"/>
                  </a:cubicBezTo>
                  <a:cubicBezTo>
                    <a:pt x="813646" y="-3889"/>
                    <a:pt x="686598" y="19652"/>
                    <a:pt x="784860" y="0"/>
                  </a:cubicBezTo>
                  <a:cubicBezTo>
                    <a:pt x="876300" y="2540"/>
                    <a:pt x="967825" y="2935"/>
                    <a:pt x="1059180" y="7620"/>
                  </a:cubicBezTo>
                  <a:cubicBezTo>
                    <a:pt x="1067202" y="8031"/>
                    <a:pt x="1082040" y="15240"/>
                    <a:pt x="1082040" y="15240"/>
                  </a:cubicBezTo>
                </a:path>
              </a:pathLst>
            </a:custGeom>
            <a:noFill/>
            <a:ln w="19050">
              <a:solidFill>
                <a:srgbClr val="FFFF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0C4A8F7-972F-E104-4ABD-27125BF3010D}"/>
                </a:ext>
              </a:extLst>
            </p:cNvPr>
            <p:cNvSpPr txBox="1"/>
            <p:nvPr/>
          </p:nvSpPr>
          <p:spPr>
            <a:xfrm>
              <a:off x="7254749" y="5032291"/>
              <a:ext cx="55496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Upp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E15FF71A-DCCB-595E-7556-E9EC55ECE4CE}"/>
                </a:ext>
              </a:extLst>
            </p:cNvPr>
            <p:cNvSpPr txBox="1"/>
            <p:nvPr/>
          </p:nvSpPr>
          <p:spPr>
            <a:xfrm>
              <a:off x="7254749" y="5464567"/>
              <a:ext cx="56137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>
                  <a:solidFill>
                    <a:srgbClr val="FF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ower</a:t>
              </a:r>
              <a:endParaRPr lang="ko-KR" altLang="en-US" sz="10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4" name="그림 43">
              <a:extLst>
                <a:ext uri="{FF2B5EF4-FFF2-40B4-BE49-F238E27FC236}">
                  <a16:creationId xmlns:a16="http://schemas.microsoft.com/office/drawing/2014/main" id="{5EDFAAA3-6B16-FC1D-4A0A-5F64FDF4F3B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8342543" y="546027"/>
              <a:ext cx="1087794" cy="6123600"/>
            </a:xfrm>
            <a:prstGeom prst="rect">
              <a:avLst/>
            </a:prstGeom>
          </p:spPr>
        </p:pic>
        <p:sp>
          <p:nvSpPr>
            <p:cNvPr id="45" name="자유형: 도형 44">
              <a:extLst>
                <a:ext uri="{FF2B5EF4-FFF2-40B4-BE49-F238E27FC236}">
                  <a16:creationId xmlns:a16="http://schemas.microsoft.com/office/drawing/2014/main" id="{670248C2-F46A-F536-2443-54638D6D7425}"/>
                </a:ext>
              </a:extLst>
            </p:cNvPr>
            <p:cNvSpPr/>
            <p:nvPr/>
          </p:nvSpPr>
          <p:spPr>
            <a:xfrm>
              <a:off x="7244080" y="5209514"/>
              <a:ext cx="1059180" cy="365760"/>
            </a:xfrm>
            <a:custGeom>
              <a:avLst/>
              <a:gdLst>
                <a:gd name="connsiteX0" fmla="*/ 0 w 1059180"/>
                <a:gd name="connsiteY0" fmla="*/ 365760 h 365760"/>
                <a:gd name="connsiteX1" fmla="*/ 38100 w 1059180"/>
                <a:gd name="connsiteY1" fmla="*/ 350520 h 365760"/>
                <a:gd name="connsiteX2" fmla="*/ 68580 w 1059180"/>
                <a:gd name="connsiteY2" fmla="*/ 312420 h 365760"/>
                <a:gd name="connsiteX3" fmla="*/ 76200 w 1059180"/>
                <a:gd name="connsiteY3" fmla="*/ 289560 h 365760"/>
                <a:gd name="connsiteX4" fmla="*/ 99060 w 1059180"/>
                <a:gd name="connsiteY4" fmla="*/ 281940 h 365760"/>
                <a:gd name="connsiteX5" fmla="*/ 114300 w 1059180"/>
                <a:gd name="connsiteY5" fmla="*/ 251460 h 365760"/>
                <a:gd name="connsiteX6" fmla="*/ 160020 w 1059180"/>
                <a:gd name="connsiteY6" fmla="*/ 236220 h 365760"/>
                <a:gd name="connsiteX7" fmla="*/ 220980 w 1059180"/>
                <a:gd name="connsiteY7" fmla="*/ 205740 h 365760"/>
                <a:gd name="connsiteX8" fmla="*/ 266700 w 1059180"/>
                <a:gd name="connsiteY8" fmla="*/ 175260 h 365760"/>
                <a:gd name="connsiteX9" fmla="*/ 327660 w 1059180"/>
                <a:gd name="connsiteY9" fmla="*/ 152400 h 365760"/>
                <a:gd name="connsiteX10" fmla="*/ 495300 w 1059180"/>
                <a:gd name="connsiteY10" fmla="*/ 144780 h 365760"/>
                <a:gd name="connsiteX11" fmla="*/ 563880 w 1059180"/>
                <a:gd name="connsiteY11" fmla="*/ 106680 h 365760"/>
                <a:gd name="connsiteX12" fmla="*/ 586740 w 1059180"/>
                <a:gd name="connsiteY12" fmla="*/ 99060 h 365760"/>
                <a:gd name="connsiteX13" fmla="*/ 739140 w 1059180"/>
                <a:gd name="connsiteY13" fmla="*/ 68580 h 365760"/>
                <a:gd name="connsiteX14" fmla="*/ 777240 w 1059180"/>
                <a:gd name="connsiteY14" fmla="*/ 38100 h 365760"/>
                <a:gd name="connsiteX15" fmla="*/ 914400 w 1059180"/>
                <a:gd name="connsiteY15" fmla="*/ 30480 h 365760"/>
                <a:gd name="connsiteX16" fmla="*/ 975360 w 1059180"/>
                <a:gd name="connsiteY16" fmla="*/ 22860 h 365760"/>
                <a:gd name="connsiteX17" fmla="*/ 1051560 w 1059180"/>
                <a:gd name="connsiteY17" fmla="*/ 7620 h 365760"/>
                <a:gd name="connsiteX18" fmla="*/ 1059180 w 1059180"/>
                <a:gd name="connsiteY18" fmla="*/ 0 h 36576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</a:cxnLst>
              <a:rect l="l" t="t" r="r" b="b"/>
              <a:pathLst>
                <a:path w="1059180" h="365760">
                  <a:moveTo>
                    <a:pt x="0" y="365760"/>
                  </a:moveTo>
                  <a:cubicBezTo>
                    <a:pt x="12700" y="360680"/>
                    <a:pt x="27303" y="358918"/>
                    <a:pt x="38100" y="350520"/>
                  </a:cubicBezTo>
                  <a:cubicBezTo>
                    <a:pt x="50938" y="340535"/>
                    <a:pt x="59960" y="326212"/>
                    <a:pt x="68580" y="312420"/>
                  </a:cubicBezTo>
                  <a:cubicBezTo>
                    <a:pt x="72837" y="305609"/>
                    <a:pt x="70520" y="295240"/>
                    <a:pt x="76200" y="289560"/>
                  </a:cubicBezTo>
                  <a:cubicBezTo>
                    <a:pt x="81880" y="283880"/>
                    <a:pt x="91440" y="284480"/>
                    <a:pt x="99060" y="281940"/>
                  </a:cubicBezTo>
                  <a:cubicBezTo>
                    <a:pt x="104140" y="271780"/>
                    <a:pt x="105213" y="258276"/>
                    <a:pt x="114300" y="251460"/>
                  </a:cubicBezTo>
                  <a:cubicBezTo>
                    <a:pt x="127151" y="241821"/>
                    <a:pt x="146654" y="245131"/>
                    <a:pt x="160020" y="236220"/>
                  </a:cubicBezTo>
                  <a:cubicBezTo>
                    <a:pt x="231704" y="188431"/>
                    <a:pt x="118453" y="261664"/>
                    <a:pt x="220980" y="205740"/>
                  </a:cubicBezTo>
                  <a:cubicBezTo>
                    <a:pt x="237060" y="196969"/>
                    <a:pt x="250317" y="183451"/>
                    <a:pt x="266700" y="175260"/>
                  </a:cubicBezTo>
                  <a:cubicBezTo>
                    <a:pt x="288133" y="164544"/>
                    <a:pt x="303137" y="154286"/>
                    <a:pt x="327660" y="152400"/>
                  </a:cubicBezTo>
                  <a:cubicBezTo>
                    <a:pt x="383433" y="148110"/>
                    <a:pt x="439420" y="147320"/>
                    <a:pt x="495300" y="144780"/>
                  </a:cubicBezTo>
                  <a:cubicBezTo>
                    <a:pt x="525093" y="124918"/>
                    <a:pt x="523447" y="124650"/>
                    <a:pt x="563880" y="106680"/>
                  </a:cubicBezTo>
                  <a:cubicBezTo>
                    <a:pt x="571220" y="103418"/>
                    <a:pt x="579120" y="101600"/>
                    <a:pt x="586740" y="99060"/>
                  </a:cubicBezTo>
                  <a:cubicBezTo>
                    <a:pt x="664195" y="40969"/>
                    <a:pt x="558375" y="111619"/>
                    <a:pt x="739140" y="68580"/>
                  </a:cubicBezTo>
                  <a:cubicBezTo>
                    <a:pt x="754962" y="64813"/>
                    <a:pt x="761347" y="41555"/>
                    <a:pt x="777240" y="38100"/>
                  </a:cubicBezTo>
                  <a:cubicBezTo>
                    <a:pt x="821985" y="28373"/>
                    <a:pt x="868680" y="33020"/>
                    <a:pt x="914400" y="30480"/>
                  </a:cubicBezTo>
                  <a:lnTo>
                    <a:pt x="975360" y="22860"/>
                  </a:lnTo>
                  <a:cubicBezTo>
                    <a:pt x="994507" y="20307"/>
                    <a:pt x="1030509" y="18146"/>
                    <a:pt x="1051560" y="7620"/>
                  </a:cubicBezTo>
                  <a:cubicBezTo>
                    <a:pt x="1054773" y="6014"/>
                    <a:pt x="1056640" y="2540"/>
                    <a:pt x="1059180" y="0"/>
                  </a:cubicBezTo>
                </a:path>
              </a:pathLst>
            </a:custGeom>
            <a:noFill/>
            <a:ln w="19050">
              <a:solidFill>
                <a:srgbClr val="FFFF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자유형: 도형 47">
              <a:extLst>
                <a:ext uri="{FF2B5EF4-FFF2-40B4-BE49-F238E27FC236}">
                  <a16:creationId xmlns:a16="http://schemas.microsoft.com/office/drawing/2014/main" id="{CFA1163D-0730-0F85-58B6-07F8A6E00C8F}"/>
                </a:ext>
              </a:extLst>
            </p:cNvPr>
            <p:cNvSpPr/>
            <p:nvPr/>
          </p:nvSpPr>
          <p:spPr>
            <a:xfrm>
              <a:off x="2784162" y="5445111"/>
              <a:ext cx="1079500" cy="101600"/>
            </a:xfrm>
            <a:custGeom>
              <a:avLst/>
              <a:gdLst>
                <a:gd name="connsiteX0" fmla="*/ 0 w 1079500"/>
                <a:gd name="connsiteY0" fmla="*/ 101600 h 101600"/>
                <a:gd name="connsiteX1" fmla="*/ 50800 w 1079500"/>
                <a:gd name="connsiteY1" fmla="*/ 57150 h 101600"/>
                <a:gd name="connsiteX2" fmla="*/ 76200 w 1079500"/>
                <a:gd name="connsiteY2" fmla="*/ 44450 h 101600"/>
                <a:gd name="connsiteX3" fmla="*/ 355600 w 1079500"/>
                <a:gd name="connsiteY3" fmla="*/ 31750 h 101600"/>
                <a:gd name="connsiteX4" fmla="*/ 374650 w 1079500"/>
                <a:gd name="connsiteY4" fmla="*/ 25400 h 101600"/>
                <a:gd name="connsiteX5" fmla="*/ 654050 w 1079500"/>
                <a:gd name="connsiteY5" fmla="*/ 12700 h 101600"/>
                <a:gd name="connsiteX6" fmla="*/ 768350 w 1079500"/>
                <a:gd name="connsiteY6" fmla="*/ 0 h 101600"/>
                <a:gd name="connsiteX7" fmla="*/ 863600 w 1079500"/>
                <a:gd name="connsiteY7" fmla="*/ 6350 h 101600"/>
                <a:gd name="connsiteX8" fmla="*/ 1079500 w 1079500"/>
                <a:gd name="connsiteY8" fmla="*/ 12700 h 1016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1079500" h="101600">
                  <a:moveTo>
                    <a:pt x="0" y="101600"/>
                  </a:moveTo>
                  <a:cubicBezTo>
                    <a:pt x="23417" y="78183"/>
                    <a:pt x="26297" y="71151"/>
                    <a:pt x="50800" y="57150"/>
                  </a:cubicBezTo>
                  <a:cubicBezTo>
                    <a:pt x="59019" y="52454"/>
                    <a:pt x="66767" y="45236"/>
                    <a:pt x="76200" y="44450"/>
                  </a:cubicBezTo>
                  <a:cubicBezTo>
                    <a:pt x="169107" y="36708"/>
                    <a:pt x="355600" y="31750"/>
                    <a:pt x="355600" y="31750"/>
                  </a:cubicBezTo>
                  <a:cubicBezTo>
                    <a:pt x="361950" y="29633"/>
                    <a:pt x="368116" y="26852"/>
                    <a:pt x="374650" y="25400"/>
                  </a:cubicBezTo>
                  <a:cubicBezTo>
                    <a:pt x="458805" y="6699"/>
                    <a:pt x="608053" y="13910"/>
                    <a:pt x="654050" y="12700"/>
                  </a:cubicBezTo>
                  <a:cubicBezTo>
                    <a:pt x="687116" y="7976"/>
                    <a:pt x="737530" y="0"/>
                    <a:pt x="768350" y="0"/>
                  </a:cubicBezTo>
                  <a:cubicBezTo>
                    <a:pt x="800170" y="0"/>
                    <a:pt x="831850" y="4233"/>
                    <a:pt x="863600" y="6350"/>
                  </a:cubicBezTo>
                  <a:cubicBezTo>
                    <a:pt x="950604" y="28101"/>
                    <a:pt x="880273" y="12700"/>
                    <a:pt x="1079500" y="12700"/>
                  </a:cubicBezTo>
                </a:path>
              </a:pathLst>
            </a:custGeom>
            <a:noFill/>
            <a:ln w="19050">
              <a:solidFill>
                <a:srgbClr val="FFFF00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2899574994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>
            <a:extLst>
              <a:ext uri="{FF2B5EF4-FFF2-40B4-BE49-F238E27FC236}">
                <a16:creationId xmlns:a16="http://schemas.microsoft.com/office/drawing/2014/main" id="{58619C09-2E5C-1C31-FC6A-C198E8A2EA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2528">
            <a:off x="3463670" y="280302"/>
            <a:ext cx="7920000" cy="7920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7899776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EEF63221-1530-962F-6943-70398965AC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2528">
            <a:off x="3463670" y="280302"/>
            <a:ext cx="7920000" cy="7920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56475200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D5E2B50F-3279-6485-0C9C-5D56BCA608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92528">
            <a:off x="3463670" y="280302"/>
            <a:ext cx="7920000" cy="7920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8300509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>
            <a:extLst>
              <a:ext uri="{FF2B5EF4-FFF2-40B4-BE49-F238E27FC236}">
                <a16:creationId xmlns:a16="http://schemas.microsoft.com/office/drawing/2014/main" id="{08E0E023-5D6B-3E92-5E5C-2015F203D8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82426" y="624793"/>
            <a:ext cx="1087794" cy="61236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62406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2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sz="12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ECBAD9FC-9F89-446C-8B48-21F3359E9689}"/>
              </a:ext>
            </a:extLst>
          </p:cNvPr>
          <p:cNvCxnSpPr>
            <a:cxnSpLocks/>
          </p:cNvCxnSpPr>
          <p:nvPr/>
        </p:nvCxnSpPr>
        <p:spPr>
          <a:xfrm>
            <a:off x="10370107" y="729111"/>
            <a:ext cx="777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DA5514C-7651-A218-45BF-D70CA9FAB257}"/>
              </a:ext>
            </a:extLst>
          </p:cNvPr>
          <p:cNvSpPr txBox="1"/>
          <p:nvPr/>
        </p:nvSpPr>
        <p:spPr>
          <a:xfrm>
            <a:off x="4530526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A2F96E-0AE1-07C0-C488-B9D778C4487E}"/>
              </a:ext>
            </a:extLst>
          </p:cNvPr>
          <p:cNvSpPr txBox="1"/>
          <p:nvPr/>
        </p:nvSpPr>
        <p:spPr>
          <a:xfrm>
            <a:off x="341159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09B721-92CF-4A2F-902C-04E5F21B88DC}"/>
              </a:ext>
            </a:extLst>
          </p:cNvPr>
          <p:cNvSpPr txBox="1"/>
          <p:nvPr/>
        </p:nvSpPr>
        <p:spPr>
          <a:xfrm>
            <a:off x="4498849" y="506241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5CD97B-C0BA-4FE0-BF6B-C9BB24E581F6}"/>
              </a:ext>
            </a:extLst>
          </p:cNvPr>
          <p:cNvSpPr txBox="1"/>
          <p:nvPr/>
        </p:nvSpPr>
        <p:spPr>
          <a:xfrm>
            <a:off x="4498849" y="5523877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B91C71-B346-D13F-403B-3BB8BD74701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27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AA0E8D27-F3B6-8A9E-4522-42EE12AE4BF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86643" y="624793"/>
            <a:ext cx="1087794" cy="6123600"/>
          </a:xfrm>
          <a:prstGeom prst="rect">
            <a:avLst/>
          </a:prstGeom>
        </p:spPr>
      </p:pic>
      <p:sp>
        <p:nvSpPr>
          <p:cNvPr id="14" name="자유형: 도형 13">
            <a:extLst>
              <a:ext uri="{FF2B5EF4-FFF2-40B4-BE49-F238E27FC236}">
                <a16:creationId xmlns:a16="http://schemas.microsoft.com/office/drawing/2014/main" id="{F4FA43C5-1667-7EBF-273D-27AD80D196ED}"/>
              </a:ext>
            </a:extLst>
          </p:cNvPr>
          <p:cNvSpPr/>
          <p:nvPr/>
        </p:nvSpPr>
        <p:spPr>
          <a:xfrm>
            <a:off x="4488180" y="5288280"/>
            <a:ext cx="1059180" cy="365760"/>
          </a:xfrm>
          <a:custGeom>
            <a:avLst/>
            <a:gdLst>
              <a:gd name="connsiteX0" fmla="*/ 0 w 1059180"/>
              <a:gd name="connsiteY0" fmla="*/ 365760 h 365760"/>
              <a:gd name="connsiteX1" fmla="*/ 38100 w 1059180"/>
              <a:gd name="connsiteY1" fmla="*/ 350520 h 365760"/>
              <a:gd name="connsiteX2" fmla="*/ 68580 w 1059180"/>
              <a:gd name="connsiteY2" fmla="*/ 312420 h 365760"/>
              <a:gd name="connsiteX3" fmla="*/ 76200 w 1059180"/>
              <a:gd name="connsiteY3" fmla="*/ 289560 h 365760"/>
              <a:gd name="connsiteX4" fmla="*/ 99060 w 1059180"/>
              <a:gd name="connsiteY4" fmla="*/ 281940 h 365760"/>
              <a:gd name="connsiteX5" fmla="*/ 114300 w 1059180"/>
              <a:gd name="connsiteY5" fmla="*/ 251460 h 365760"/>
              <a:gd name="connsiteX6" fmla="*/ 160020 w 1059180"/>
              <a:gd name="connsiteY6" fmla="*/ 236220 h 365760"/>
              <a:gd name="connsiteX7" fmla="*/ 220980 w 1059180"/>
              <a:gd name="connsiteY7" fmla="*/ 205740 h 365760"/>
              <a:gd name="connsiteX8" fmla="*/ 266700 w 1059180"/>
              <a:gd name="connsiteY8" fmla="*/ 175260 h 365760"/>
              <a:gd name="connsiteX9" fmla="*/ 327660 w 1059180"/>
              <a:gd name="connsiteY9" fmla="*/ 152400 h 365760"/>
              <a:gd name="connsiteX10" fmla="*/ 495300 w 1059180"/>
              <a:gd name="connsiteY10" fmla="*/ 144780 h 365760"/>
              <a:gd name="connsiteX11" fmla="*/ 563880 w 1059180"/>
              <a:gd name="connsiteY11" fmla="*/ 106680 h 365760"/>
              <a:gd name="connsiteX12" fmla="*/ 586740 w 1059180"/>
              <a:gd name="connsiteY12" fmla="*/ 99060 h 365760"/>
              <a:gd name="connsiteX13" fmla="*/ 739140 w 1059180"/>
              <a:gd name="connsiteY13" fmla="*/ 68580 h 365760"/>
              <a:gd name="connsiteX14" fmla="*/ 777240 w 1059180"/>
              <a:gd name="connsiteY14" fmla="*/ 38100 h 365760"/>
              <a:gd name="connsiteX15" fmla="*/ 914400 w 1059180"/>
              <a:gd name="connsiteY15" fmla="*/ 30480 h 365760"/>
              <a:gd name="connsiteX16" fmla="*/ 975360 w 1059180"/>
              <a:gd name="connsiteY16" fmla="*/ 22860 h 365760"/>
              <a:gd name="connsiteX17" fmla="*/ 1051560 w 1059180"/>
              <a:gd name="connsiteY17" fmla="*/ 7620 h 365760"/>
              <a:gd name="connsiteX18" fmla="*/ 1059180 w 1059180"/>
              <a:gd name="connsiteY18" fmla="*/ 0 h 365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059180" h="365760">
                <a:moveTo>
                  <a:pt x="0" y="365760"/>
                </a:moveTo>
                <a:cubicBezTo>
                  <a:pt x="12700" y="360680"/>
                  <a:pt x="27303" y="358918"/>
                  <a:pt x="38100" y="350520"/>
                </a:cubicBezTo>
                <a:cubicBezTo>
                  <a:pt x="50938" y="340535"/>
                  <a:pt x="59960" y="326212"/>
                  <a:pt x="68580" y="312420"/>
                </a:cubicBezTo>
                <a:cubicBezTo>
                  <a:pt x="72837" y="305609"/>
                  <a:pt x="70520" y="295240"/>
                  <a:pt x="76200" y="289560"/>
                </a:cubicBezTo>
                <a:cubicBezTo>
                  <a:pt x="81880" y="283880"/>
                  <a:pt x="91440" y="284480"/>
                  <a:pt x="99060" y="281940"/>
                </a:cubicBezTo>
                <a:cubicBezTo>
                  <a:pt x="104140" y="271780"/>
                  <a:pt x="105213" y="258276"/>
                  <a:pt x="114300" y="251460"/>
                </a:cubicBezTo>
                <a:cubicBezTo>
                  <a:pt x="127151" y="241821"/>
                  <a:pt x="146654" y="245131"/>
                  <a:pt x="160020" y="236220"/>
                </a:cubicBezTo>
                <a:cubicBezTo>
                  <a:pt x="231704" y="188431"/>
                  <a:pt x="118453" y="261664"/>
                  <a:pt x="220980" y="205740"/>
                </a:cubicBezTo>
                <a:cubicBezTo>
                  <a:pt x="237060" y="196969"/>
                  <a:pt x="250317" y="183451"/>
                  <a:pt x="266700" y="175260"/>
                </a:cubicBezTo>
                <a:cubicBezTo>
                  <a:pt x="288133" y="164544"/>
                  <a:pt x="303137" y="154286"/>
                  <a:pt x="327660" y="152400"/>
                </a:cubicBezTo>
                <a:cubicBezTo>
                  <a:pt x="383433" y="148110"/>
                  <a:pt x="439420" y="147320"/>
                  <a:pt x="495300" y="144780"/>
                </a:cubicBezTo>
                <a:cubicBezTo>
                  <a:pt x="525093" y="124918"/>
                  <a:pt x="523447" y="124650"/>
                  <a:pt x="563880" y="106680"/>
                </a:cubicBezTo>
                <a:cubicBezTo>
                  <a:pt x="571220" y="103418"/>
                  <a:pt x="579120" y="101600"/>
                  <a:pt x="586740" y="99060"/>
                </a:cubicBezTo>
                <a:cubicBezTo>
                  <a:pt x="664195" y="40969"/>
                  <a:pt x="558375" y="111619"/>
                  <a:pt x="739140" y="68580"/>
                </a:cubicBezTo>
                <a:cubicBezTo>
                  <a:pt x="754962" y="64813"/>
                  <a:pt x="761347" y="41555"/>
                  <a:pt x="777240" y="38100"/>
                </a:cubicBezTo>
                <a:cubicBezTo>
                  <a:pt x="821985" y="28373"/>
                  <a:pt x="868680" y="33020"/>
                  <a:pt x="914400" y="30480"/>
                </a:cubicBezTo>
                <a:lnTo>
                  <a:pt x="975360" y="22860"/>
                </a:lnTo>
                <a:cubicBezTo>
                  <a:pt x="994507" y="20307"/>
                  <a:pt x="1030509" y="18146"/>
                  <a:pt x="1051560" y="7620"/>
                </a:cubicBezTo>
                <a:cubicBezTo>
                  <a:pt x="1054773" y="6014"/>
                  <a:pt x="1056640" y="2540"/>
                  <a:pt x="1059180" y="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pic>
        <p:nvPicPr>
          <p:cNvPr id="16" name="그림 15">
            <a:extLst>
              <a:ext uri="{FF2B5EF4-FFF2-40B4-BE49-F238E27FC236}">
                <a16:creationId xmlns:a16="http://schemas.microsoft.com/office/drawing/2014/main" id="{4A5D3927-BCFF-2772-4C80-1AEAE9D8BDB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1694" y="624793"/>
            <a:ext cx="1087794" cy="6123600"/>
          </a:xfrm>
          <a:prstGeom prst="rect">
            <a:avLst/>
          </a:prstGeom>
        </p:spPr>
      </p:pic>
      <p:sp>
        <p:nvSpPr>
          <p:cNvPr id="17" name="자유형: 도형 16">
            <a:extLst>
              <a:ext uri="{FF2B5EF4-FFF2-40B4-BE49-F238E27FC236}">
                <a16:creationId xmlns:a16="http://schemas.microsoft.com/office/drawing/2014/main" id="{48F1E34F-B999-E865-CEC8-3DAC02BD2BEE}"/>
              </a:ext>
            </a:extLst>
          </p:cNvPr>
          <p:cNvSpPr/>
          <p:nvPr/>
        </p:nvSpPr>
        <p:spPr>
          <a:xfrm>
            <a:off x="3383280" y="5288280"/>
            <a:ext cx="1059180" cy="365760"/>
          </a:xfrm>
          <a:custGeom>
            <a:avLst/>
            <a:gdLst>
              <a:gd name="connsiteX0" fmla="*/ 0 w 1059180"/>
              <a:gd name="connsiteY0" fmla="*/ 365760 h 365760"/>
              <a:gd name="connsiteX1" fmla="*/ 38100 w 1059180"/>
              <a:gd name="connsiteY1" fmla="*/ 350520 h 365760"/>
              <a:gd name="connsiteX2" fmla="*/ 68580 w 1059180"/>
              <a:gd name="connsiteY2" fmla="*/ 312420 h 365760"/>
              <a:gd name="connsiteX3" fmla="*/ 76200 w 1059180"/>
              <a:gd name="connsiteY3" fmla="*/ 289560 h 365760"/>
              <a:gd name="connsiteX4" fmla="*/ 99060 w 1059180"/>
              <a:gd name="connsiteY4" fmla="*/ 281940 h 365760"/>
              <a:gd name="connsiteX5" fmla="*/ 114300 w 1059180"/>
              <a:gd name="connsiteY5" fmla="*/ 251460 h 365760"/>
              <a:gd name="connsiteX6" fmla="*/ 160020 w 1059180"/>
              <a:gd name="connsiteY6" fmla="*/ 236220 h 365760"/>
              <a:gd name="connsiteX7" fmla="*/ 220980 w 1059180"/>
              <a:gd name="connsiteY7" fmla="*/ 205740 h 365760"/>
              <a:gd name="connsiteX8" fmla="*/ 266700 w 1059180"/>
              <a:gd name="connsiteY8" fmla="*/ 175260 h 365760"/>
              <a:gd name="connsiteX9" fmla="*/ 327660 w 1059180"/>
              <a:gd name="connsiteY9" fmla="*/ 152400 h 365760"/>
              <a:gd name="connsiteX10" fmla="*/ 495300 w 1059180"/>
              <a:gd name="connsiteY10" fmla="*/ 144780 h 365760"/>
              <a:gd name="connsiteX11" fmla="*/ 563880 w 1059180"/>
              <a:gd name="connsiteY11" fmla="*/ 106680 h 365760"/>
              <a:gd name="connsiteX12" fmla="*/ 586740 w 1059180"/>
              <a:gd name="connsiteY12" fmla="*/ 99060 h 365760"/>
              <a:gd name="connsiteX13" fmla="*/ 739140 w 1059180"/>
              <a:gd name="connsiteY13" fmla="*/ 68580 h 365760"/>
              <a:gd name="connsiteX14" fmla="*/ 777240 w 1059180"/>
              <a:gd name="connsiteY14" fmla="*/ 38100 h 365760"/>
              <a:gd name="connsiteX15" fmla="*/ 914400 w 1059180"/>
              <a:gd name="connsiteY15" fmla="*/ 30480 h 365760"/>
              <a:gd name="connsiteX16" fmla="*/ 975360 w 1059180"/>
              <a:gd name="connsiteY16" fmla="*/ 22860 h 365760"/>
              <a:gd name="connsiteX17" fmla="*/ 1051560 w 1059180"/>
              <a:gd name="connsiteY17" fmla="*/ 7620 h 365760"/>
              <a:gd name="connsiteX18" fmla="*/ 1059180 w 1059180"/>
              <a:gd name="connsiteY18" fmla="*/ 0 h 36576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1059180" h="365760">
                <a:moveTo>
                  <a:pt x="0" y="365760"/>
                </a:moveTo>
                <a:cubicBezTo>
                  <a:pt x="12700" y="360680"/>
                  <a:pt x="27303" y="358918"/>
                  <a:pt x="38100" y="350520"/>
                </a:cubicBezTo>
                <a:cubicBezTo>
                  <a:pt x="50938" y="340535"/>
                  <a:pt x="59960" y="326212"/>
                  <a:pt x="68580" y="312420"/>
                </a:cubicBezTo>
                <a:cubicBezTo>
                  <a:pt x="72837" y="305609"/>
                  <a:pt x="70520" y="295240"/>
                  <a:pt x="76200" y="289560"/>
                </a:cubicBezTo>
                <a:cubicBezTo>
                  <a:pt x="81880" y="283880"/>
                  <a:pt x="91440" y="284480"/>
                  <a:pt x="99060" y="281940"/>
                </a:cubicBezTo>
                <a:cubicBezTo>
                  <a:pt x="104140" y="271780"/>
                  <a:pt x="105213" y="258276"/>
                  <a:pt x="114300" y="251460"/>
                </a:cubicBezTo>
                <a:cubicBezTo>
                  <a:pt x="127151" y="241821"/>
                  <a:pt x="146654" y="245131"/>
                  <a:pt x="160020" y="236220"/>
                </a:cubicBezTo>
                <a:cubicBezTo>
                  <a:pt x="231704" y="188431"/>
                  <a:pt x="118453" y="261664"/>
                  <a:pt x="220980" y="205740"/>
                </a:cubicBezTo>
                <a:cubicBezTo>
                  <a:pt x="237060" y="196969"/>
                  <a:pt x="250317" y="183451"/>
                  <a:pt x="266700" y="175260"/>
                </a:cubicBezTo>
                <a:cubicBezTo>
                  <a:pt x="288133" y="164544"/>
                  <a:pt x="303137" y="154286"/>
                  <a:pt x="327660" y="152400"/>
                </a:cubicBezTo>
                <a:cubicBezTo>
                  <a:pt x="383433" y="148110"/>
                  <a:pt x="439420" y="147320"/>
                  <a:pt x="495300" y="144780"/>
                </a:cubicBezTo>
                <a:cubicBezTo>
                  <a:pt x="525093" y="124918"/>
                  <a:pt x="523447" y="124650"/>
                  <a:pt x="563880" y="106680"/>
                </a:cubicBezTo>
                <a:cubicBezTo>
                  <a:pt x="571220" y="103418"/>
                  <a:pt x="579120" y="101600"/>
                  <a:pt x="586740" y="99060"/>
                </a:cubicBezTo>
                <a:cubicBezTo>
                  <a:pt x="664195" y="40969"/>
                  <a:pt x="558375" y="111619"/>
                  <a:pt x="739140" y="68580"/>
                </a:cubicBezTo>
                <a:cubicBezTo>
                  <a:pt x="754962" y="64813"/>
                  <a:pt x="761347" y="41555"/>
                  <a:pt x="777240" y="38100"/>
                </a:cubicBezTo>
                <a:cubicBezTo>
                  <a:pt x="821985" y="28373"/>
                  <a:pt x="868680" y="33020"/>
                  <a:pt x="914400" y="30480"/>
                </a:cubicBezTo>
                <a:lnTo>
                  <a:pt x="975360" y="22860"/>
                </a:lnTo>
                <a:cubicBezTo>
                  <a:pt x="994507" y="20307"/>
                  <a:pt x="1030509" y="18146"/>
                  <a:pt x="1051560" y="7620"/>
                </a:cubicBezTo>
                <a:cubicBezTo>
                  <a:pt x="1054773" y="6014"/>
                  <a:pt x="1056640" y="2540"/>
                  <a:pt x="1059180" y="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0661079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그룹 17">
            <a:extLst>
              <a:ext uri="{FF2B5EF4-FFF2-40B4-BE49-F238E27FC236}">
                <a16:creationId xmlns:a16="http://schemas.microsoft.com/office/drawing/2014/main" id="{7847DF89-6B5B-4E34-8E25-B87E320D572C}"/>
              </a:ext>
            </a:extLst>
          </p:cNvPr>
          <p:cNvGrpSpPr/>
          <p:nvPr/>
        </p:nvGrpSpPr>
        <p:grpSpPr>
          <a:xfrm>
            <a:off x="1801585" y="175407"/>
            <a:ext cx="6986815" cy="6539876"/>
            <a:chOff x="1801585" y="175407"/>
            <a:chExt cx="6986815" cy="6539876"/>
          </a:xfrm>
        </p:grpSpPr>
        <p:pic>
          <p:nvPicPr>
            <p:cNvPr id="5" name="그림 4">
              <a:extLst>
                <a:ext uri="{FF2B5EF4-FFF2-40B4-BE49-F238E27FC236}">
                  <a16:creationId xmlns:a16="http://schemas.microsoft.com/office/drawing/2014/main" id="{8C972FA6-E2C6-4B4E-8C35-D203D40385E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143753" y="590708"/>
              <a:ext cx="2162175" cy="6124575"/>
            </a:xfrm>
            <a:prstGeom prst="rect">
              <a:avLst/>
            </a:prstGeom>
          </p:spPr>
        </p:pic>
        <p:pic>
          <p:nvPicPr>
            <p:cNvPr id="6" name="그림 5">
              <a:extLst>
                <a:ext uri="{FF2B5EF4-FFF2-40B4-BE49-F238E27FC236}">
                  <a16:creationId xmlns:a16="http://schemas.microsoft.com/office/drawing/2014/main" id="{BA80704B-61C1-4E27-8668-0191E5773D3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01585" y="590708"/>
              <a:ext cx="2162175" cy="6124575"/>
            </a:xfrm>
            <a:prstGeom prst="rect">
              <a:avLst/>
            </a:prstGeom>
          </p:spPr>
        </p:pic>
        <p:pic>
          <p:nvPicPr>
            <p:cNvPr id="7" name="그림 6">
              <a:extLst>
                <a:ext uri="{FF2B5EF4-FFF2-40B4-BE49-F238E27FC236}">
                  <a16:creationId xmlns:a16="http://schemas.microsoft.com/office/drawing/2014/main" id="{C3621FF8-6167-4233-8AA6-EA368EE2CC0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3973285" y="590708"/>
              <a:ext cx="2162175" cy="6124575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FBB9445-63DA-4D65-81AF-16268B3DDAC6}"/>
                </a:ext>
              </a:extLst>
            </p:cNvPr>
            <p:cNvSpPr txBox="1"/>
            <p:nvPr/>
          </p:nvSpPr>
          <p:spPr>
            <a:xfrm>
              <a:off x="1832218" y="175407"/>
              <a:ext cx="2088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EF100D9-700A-427F-9720-98C1AA1DA541}"/>
                </a:ext>
              </a:extLst>
            </p:cNvPr>
            <p:cNvSpPr txBox="1"/>
            <p:nvPr/>
          </p:nvSpPr>
          <p:spPr>
            <a:xfrm>
              <a:off x="6174386" y="175407"/>
              <a:ext cx="2088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solidFill>
                    <a:srgbClr val="00FF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L1</a:t>
              </a:r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 / TAG-1 / </a:t>
              </a:r>
              <a:r>
                <a:rPr lang="en-US" altLang="ko-KR" b="1" dirty="0">
                  <a:solidFill>
                    <a:srgbClr val="FF00FF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FP</a:t>
              </a:r>
              <a:endParaRPr lang="ko-KR" altLang="en-US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CF7FFA03-6011-4E39-816E-B8F334FA3147}"/>
                </a:ext>
              </a:extLst>
            </p:cNvPr>
            <p:cNvSpPr txBox="1"/>
            <p:nvPr/>
          </p:nvSpPr>
          <p:spPr>
            <a:xfrm>
              <a:off x="4003302" y="175407"/>
              <a:ext cx="2088000" cy="36933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square" rtlCol="0">
              <a:noAutofit/>
            </a:bodyPr>
            <a:lstStyle/>
            <a:p>
              <a:pPr algn="ctr"/>
              <a:r>
                <a:rPr lang="en-US" altLang="ko-KR" b="1" dirty="0">
                  <a:latin typeface="Arial" panose="020B0604020202020204" pitchFamily="34" charset="0"/>
                  <a:cs typeface="Arial" panose="020B0604020202020204" pitchFamily="34" charset="0"/>
                </a:rPr>
                <a:t>TAG-1</a:t>
              </a:r>
              <a:endParaRPr lang="ko-KR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" name="직선 연결선 10">
              <a:extLst>
                <a:ext uri="{FF2B5EF4-FFF2-40B4-BE49-F238E27FC236}">
                  <a16:creationId xmlns:a16="http://schemas.microsoft.com/office/drawing/2014/main" id="{550AFA3C-B3B2-4BB9-9332-0F144E0DD324}"/>
                </a:ext>
              </a:extLst>
            </p:cNvPr>
            <p:cNvCxnSpPr/>
            <p:nvPr/>
          </p:nvCxnSpPr>
          <p:spPr>
            <a:xfrm>
              <a:off x="8305928" y="4495800"/>
              <a:ext cx="4189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직선 연결선 11">
              <a:extLst>
                <a:ext uri="{FF2B5EF4-FFF2-40B4-BE49-F238E27FC236}">
                  <a16:creationId xmlns:a16="http://schemas.microsoft.com/office/drawing/2014/main" id="{C7360C8B-1B5C-4EB7-9293-4DC3C3E1D082}"/>
                </a:ext>
              </a:extLst>
            </p:cNvPr>
            <p:cNvCxnSpPr/>
            <p:nvPr/>
          </p:nvCxnSpPr>
          <p:spPr>
            <a:xfrm>
              <a:off x="8305928" y="6070600"/>
              <a:ext cx="4189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직선 연결선 12">
              <a:extLst>
                <a:ext uri="{FF2B5EF4-FFF2-40B4-BE49-F238E27FC236}">
                  <a16:creationId xmlns:a16="http://schemas.microsoft.com/office/drawing/2014/main" id="{9403AEA6-0BF7-470E-8366-5BAA7E15480E}"/>
                </a:ext>
              </a:extLst>
            </p:cNvPr>
            <p:cNvCxnSpPr/>
            <p:nvPr/>
          </p:nvCxnSpPr>
          <p:spPr>
            <a:xfrm>
              <a:off x="8305928" y="616108"/>
              <a:ext cx="4189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>
              <a:extLst>
                <a:ext uri="{FF2B5EF4-FFF2-40B4-BE49-F238E27FC236}">
                  <a16:creationId xmlns:a16="http://schemas.microsoft.com/office/drawing/2014/main" id="{24462780-4B08-4C3E-9C0C-FB3CA41CEFD6}"/>
                </a:ext>
              </a:extLst>
            </p:cNvPr>
            <p:cNvCxnSpPr/>
            <p:nvPr/>
          </p:nvCxnSpPr>
          <p:spPr>
            <a:xfrm>
              <a:off x="8305928" y="6689883"/>
              <a:ext cx="418972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AB134809-A6A5-4C66-8303-FB92DA9DE3E8}"/>
                </a:ext>
              </a:extLst>
            </p:cNvPr>
            <p:cNvSpPr txBox="1"/>
            <p:nvPr/>
          </p:nvSpPr>
          <p:spPr>
            <a:xfrm>
              <a:off x="8305928" y="2145952"/>
              <a:ext cx="39786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CP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4ABD34F4-5E05-43D3-987D-8C1122FE9B10}"/>
                </a:ext>
              </a:extLst>
            </p:cNvPr>
            <p:cNvSpPr txBox="1"/>
            <p:nvPr/>
          </p:nvSpPr>
          <p:spPr>
            <a:xfrm>
              <a:off x="8316481" y="5144701"/>
              <a:ext cx="39786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IZ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AD773D13-CCD3-4EF6-A445-6A52A7AA40F6}"/>
                </a:ext>
              </a:extLst>
            </p:cNvPr>
            <p:cNvSpPr txBox="1"/>
            <p:nvPr/>
          </p:nvSpPr>
          <p:spPr>
            <a:xfrm>
              <a:off x="8246566" y="6149409"/>
              <a:ext cx="5418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VZ</a:t>
              </a:r>
            </a:p>
            <a:p>
              <a:pPr algn="ctr"/>
              <a:r>
                <a:rPr lang="en-US" altLang="ko-KR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SVZ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18585756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9196C24E-7A07-FC6D-D9C3-1753B26170E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20712">
            <a:off x="3450965" y="247649"/>
            <a:ext cx="685800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09533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그림 9">
            <a:extLst>
              <a:ext uri="{FF2B5EF4-FFF2-40B4-BE49-F238E27FC236}">
                <a16:creationId xmlns:a16="http://schemas.microsoft.com/office/drawing/2014/main" id="{FDA2B2DA-3C5E-C452-9816-B3501295322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20712">
            <a:off x="3450965" y="247649"/>
            <a:ext cx="685800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52020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그림 7">
            <a:extLst>
              <a:ext uri="{FF2B5EF4-FFF2-40B4-BE49-F238E27FC236}">
                <a16:creationId xmlns:a16="http://schemas.microsoft.com/office/drawing/2014/main" id="{08011F6F-3FDA-0A24-71A2-6B7A0235D3D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9220712">
            <a:off x="3450965" y="247649"/>
            <a:ext cx="685800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90D64138-34D6-4655-8897-EF0AE8F3048A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8246475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TextBox 20"/>
          <p:cNvSpPr txBox="1"/>
          <p:nvPr/>
        </p:nvSpPr>
        <p:spPr>
          <a:xfrm>
            <a:off x="562406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2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sz="12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D86066E-8D35-468A-9989-D8BA63EE6FD8}"/>
              </a:ext>
            </a:extLst>
          </p:cNvPr>
          <p:cNvSpPr txBox="1"/>
          <p:nvPr/>
        </p:nvSpPr>
        <p:spPr>
          <a:xfrm>
            <a:off x="0" y="0"/>
            <a:ext cx="165942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Con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ECBAD9FC-9F89-446C-8B48-21F3359E9689}"/>
              </a:ext>
            </a:extLst>
          </p:cNvPr>
          <p:cNvCxnSpPr>
            <a:cxnSpLocks/>
          </p:cNvCxnSpPr>
          <p:nvPr/>
        </p:nvCxnSpPr>
        <p:spPr>
          <a:xfrm>
            <a:off x="10370107" y="729111"/>
            <a:ext cx="777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그림 2">
            <a:extLst>
              <a:ext uri="{FF2B5EF4-FFF2-40B4-BE49-F238E27FC236}">
                <a16:creationId xmlns:a16="http://schemas.microsoft.com/office/drawing/2014/main" id="{37D6026A-311F-0FEB-EAC1-9D9C1881FFC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609564" y="624793"/>
            <a:ext cx="1087794" cy="6123600"/>
          </a:xfrm>
          <a:prstGeom prst="rect">
            <a:avLst/>
          </a:prstGeom>
        </p:spPr>
      </p:pic>
      <p:pic>
        <p:nvPicPr>
          <p:cNvPr id="7" name="그림 6">
            <a:extLst>
              <a:ext uri="{FF2B5EF4-FFF2-40B4-BE49-F238E27FC236}">
                <a16:creationId xmlns:a16="http://schemas.microsoft.com/office/drawing/2014/main" id="{98DD06AD-5AB6-D247-38F5-8643AE103F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0629" y="624793"/>
            <a:ext cx="1087794" cy="61236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DA5514C-7651-A218-45BF-D70CA9FAB257}"/>
              </a:ext>
            </a:extLst>
          </p:cNvPr>
          <p:cNvSpPr txBox="1"/>
          <p:nvPr/>
        </p:nvSpPr>
        <p:spPr>
          <a:xfrm>
            <a:off x="4530526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그림 9">
            <a:extLst>
              <a:ext uri="{FF2B5EF4-FFF2-40B4-BE49-F238E27FC236}">
                <a16:creationId xmlns:a16="http://schemas.microsoft.com/office/drawing/2014/main" id="{96657A66-F274-85E9-58D8-E07EF1B7AAE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71694" y="624793"/>
            <a:ext cx="1087794" cy="61236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27A2F96E-0AE1-07C0-C488-B9D778C4487E}"/>
              </a:ext>
            </a:extLst>
          </p:cNvPr>
          <p:cNvSpPr txBox="1"/>
          <p:nvPr/>
        </p:nvSpPr>
        <p:spPr>
          <a:xfrm>
            <a:off x="341159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09B721-92CF-4A2F-902C-04E5F21B88DC}"/>
              </a:ext>
            </a:extLst>
          </p:cNvPr>
          <p:cNvSpPr txBox="1"/>
          <p:nvPr/>
        </p:nvSpPr>
        <p:spPr>
          <a:xfrm>
            <a:off x="4498849" y="519195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5CD97B-C0BA-4FE0-BF6B-C9BB24E581F6}"/>
              </a:ext>
            </a:extLst>
          </p:cNvPr>
          <p:cNvSpPr txBox="1"/>
          <p:nvPr/>
        </p:nvSpPr>
        <p:spPr>
          <a:xfrm>
            <a:off x="4498849" y="5653417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자유형: 도형 21">
            <a:extLst>
              <a:ext uri="{FF2B5EF4-FFF2-40B4-BE49-F238E27FC236}">
                <a16:creationId xmlns:a16="http://schemas.microsoft.com/office/drawing/2014/main" id="{945D470D-B1D6-2E48-BA4A-9676D62E3625}"/>
              </a:ext>
            </a:extLst>
          </p:cNvPr>
          <p:cNvSpPr/>
          <p:nvPr/>
        </p:nvSpPr>
        <p:spPr>
          <a:xfrm>
            <a:off x="4497588" y="5539117"/>
            <a:ext cx="1079500" cy="101600"/>
          </a:xfrm>
          <a:custGeom>
            <a:avLst/>
            <a:gdLst>
              <a:gd name="connsiteX0" fmla="*/ 0 w 1079500"/>
              <a:gd name="connsiteY0" fmla="*/ 101600 h 101600"/>
              <a:gd name="connsiteX1" fmla="*/ 50800 w 1079500"/>
              <a:gd name="connsiteY1" fmla="*/ 57150 h 101600"/>
              <a:gd name="connsiteX2" fmla="*/ 76200 w 1079500"/>
              <a:gd name="connsiteY2" fmla="*/ 44450 h 101600"/>
              <a:gd name="connsiteX3" fmla="*/ 355600 w 1079500"/>
              <a:gd name="connsiteY3" fmla="*/ 31750 h 101600"/>
              <a:gd name="connsiteX4" fmla="*/ 374650 w 1079500"/>
              <a:gd name="connsiteY4" fmla="*/ 25400 h 101600"/>
              <a:gd name="connsiteX5" fmla="*/ 654050 w 1079500"/>
              <a:gd name="connsiteY5" fmla="*/ 12700 h 101600"/>
              <a:gd name="connsiteX6" fmla="*/ 768350 w 1079500"/>
              <a:gd name="connsiteY6" fmla="*/ 0 h 101600"/>
              <a:gd name="connsiteX7" fmla="*/ 863600 w 1079500"/>
              <a:gd name="connsiteY7" fmla="*/ 6350 h 101600"/>
              <a:gd name="connsiteX8" fmla="*/ 1079500 w 1079500"/>
              <a:gd name="connsiteY8" fmla="*/ 12700 h 101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079500" h="101600">
                <a:moveTo>
                  <a:pt x="0" y="101600"/>
                </a:moveTo>
                <a:cubicBezTo>
                  <a:pt x="23417" y="78183"/>
                  <a:pt x="26297" y="71151"/>
                  <a:pt x="50800" y="57150"/>
                </a:cubicBezTo>
                <a:cubicBezTo>
                  <a:pt x="59019" y="52454"/>
                  <a:pt x="66767" y="45236"/>
                  <a:pt x="76200" y="44450"/>
                </a:cubicBezTo>
                <a:cubicBezTo>
                  <a:pt x="169107" y="36708"/>
                  <a:pt x="355600" y="31750"/>
                  <a:pt x="355600" y="31750"/>
                </a:cubicBezTo>
                <a:cubicBezTo>
                  <a:pt x="361950" y="29633"/>
                  <a:pt x="368116" y="26852"/>
                  <a:pt x="374650" y="25400"/>
                </a:cubicBezTo>
                <a:cubicBezTo>
                  <a:pt x="458805" y="6699"/>
                  <a:pt x="608053" y="13910"/>
                  <a:pt x="654050" y="12700"/>
                </a:cubicBezTo>
                <a:cubicBezTo>
                  <a:pt x="687116" y="7976"/>
                  <a:pt x="737530" y="0"/>
                  <a:pt x="768350" y="0"/>
                </a:cubicBezTo>
                <a:cubicBezTo>
                  <a:pt x="800170" y="0"/>
                  <a:pt x="831850" y="4233"/>
                  <a:pt x="863600" y="6350"/>
                </a:cubicBezTo>
                <a:cubicBezTo>
                  <a:pt x="950604" y="28101"/>
                  <a:pt x="880273" y="12700"/>
                  <a:pt x="1079500" y="1270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24" name="자유형: 도형 23">
            <a:extLst>
              <a:ext uri="{FF2B5EF4-FFF2-40B4-BE49-F238E27FC236}">
                <a16:creationId xmlns:a16="http://schemas.microsoft.com/office/drawing/2014/main" id="{B69E1A02-D4B1-77E8-98E9-DC76C9B44537}"/>
              </a:ext>
            </a:extLst>
          </p:cNvPr>
          <p:cNvSpPr/>
          <p:nvPr/>
        </p:nvSpPr>
        <p:spPr>
          <a:xfrm>
            <a:off x="3379988" y="5537470"/>
            <a:ext cx="1079500" cy="101600"/>
          </a:xfrm>
          <a:custGeom>
            <a:avLst/>
            <a:gdLst>
              <a:gd name="connsiteX0" fmla="*/ 0 w 1079500"/>
              <a:gd name="connsiteY0" fmla="*/ 101600 h 101600"/>
              <a:gd name="connsiteX1" fmla="*/ 50800 w 1079500"/>
              <a:gd name="connsiteY1" fmla="*/ 57150 h 101600"/>
              <a:gd name="connsiteX2" fmla="*/ 76200 w 1079500"/>
              <a:gd name="connsiteY2" fmla="*/ 44450 h 101600"/>
              <a:gd name="connsiteX3" fmla="*/ 355600 w 1079500"/>
              <a:gd name="connsiteY3" fmla="*/ 31750 h 101600"/>
              <a:gd name="connsiteX4" fmla="*/ 374650 w 1079500"/>
              <a:gd name="connsiteY4" fmla="*/ 25400 h 101600"/>
              <a:gd name="connsiteX5" fmla="*/ 654050 w 1079500"/>
              <a:gd name="connsiteY5" fmla="*/ 12700 h 101600"/>
              <a:gd name="connsiteX6" fmla="*/ 768350 w 1079500"/>
              <a:gd name="connsiteY6" fmla="*/ 0 h 101600"/>
              <a:gd name="connsiteX7" fmla="*/ 863600 w 1079500"/>
              <a:gd name="connsiteY7" fmla="*/ 6350 h 101600"/>
              <a:gd name="connsiteX8" fmla="*/ 1079500 w 1079500"/>
              <a:gd name="connsiteY8" fmla="*/ 12700 h 1016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1079500" h="101600">
                <a:moveTo>
                  <a:pt x="0" y="101600"/>
                </a:moveTo>
                <a:cubicBezTo>
                  <a:pt x="23417" y="78183"/>
                  <a:pt x="26297" y="71151"/>
                  <a:pt x="50800" y="57150"/>
                </a:cubicBezTo>
                <a:cubicBezTo>
                  <a:pt x="59019" y="52454"/>
                  <a:pt x="66767" y="45236"/>
                  <a:pt x="76200" y="44450"/>
                </a:cubicBezTo>
                <a:cubicBezTo>
                  <a:pt x="169107" y="36708"/>
                  <a:pt x="355600" y="31750"/>
                  <a:pt x="355600" y="31750"/>
                </a:cubicBezTo>
                <a:cubicBezTo>
                  <a:pt x="361950" y="29633"/>
                  <a:pt x="368116" y="26852"/>
                  <a:pt x="374650" y="25400"/>
                </a:cubicBezTo>
                <a:cubicBezTo>
                  <a:pt x="458805" y="6699"/>
                  <a:pt x="608053" y="13910"/>
                  <a:pt x="654050" y="12700"/>
                </a:cubicBezTo>
                <a:cubicBezTo>
                  <a:pt x="687116" y="7976"/>
                  <a:pt x="737530" y="0"/>
                  <a:pt x="768350" y="0"/>
                </a:cubicBezTo>
                <a:cubicBezTo>
                  <a:pt x="800170" y="0"/>
                  <a:pt x="831850" y="4233"/>
                  <a:pt x="863600" y="6350"/>
                </a:cubicBezTo>
                <a:cubicBezTo>
                  <a:pt x="950604" y="28101"/>
                  <a:pt x="880273" y="12700"/>
                  <a:pt x="1079500" y="1270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796593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3D6E3406-DD0D-F38E-32C7-8B23FD7BCB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6418">
            <a:off x="4248151" y="133350"/>
            <a:ext cx="6858000" cy="6858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022549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그림 10">
            <a:extLst>
              <a:ext uri="{FF2B5EF4-FFF2-40B4-BE49-F238E27FC236}">
                <a16:creationId xmlns:a16="http://schemas.microsoft.com/office/drawing/2014/main" id="{0292D5D8-99EC-9C08-33DB-8D029859B8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6418">
            <a:off x="4248151" y="133350"/>
            <a:ext cx="6858000" cy="6858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930896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그림 8">
            <a:extLst>
              <a:ext uri="{FF2B5EF4-FFF2-40B4-BE49-F238E27FC236}">
                <a16:creationId xmlns:a16="http://schemas.microsoft.com/office/drawing/2014/main" id="{C501383C-BC95-EC6A-B499-C9ABEA66DA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896418">
            <a:off x="4248151" y="133350"/>
            <a:ext cx="6858000" cy="6858000"/>
          </a:xfrm>
          <a:prstGeom prst="rect">
            <a:avLst/>
          </a:prstGeom>
        </p:spPr>
      </p:pic>
      <p:sp>
        <p:nvSpPr>
          <p:cNvPr id="6" name="직사각형 5"/>
          <p:cNvSpPr>
            <a:spLocks/>
          </p:cNvSpPr>
          <p:nvPr/>
        </p:nvSpPr>
        <p:spPr>
          <a:xfrm rot="5400000">
            <a:off x="3978965" y="2850900"/>
            <a:ext cx="6120000" cy="1080000"/>
          </a:xfrm>
          <a:prstGeom prst="rect">
            <a:avLst/>
          </a:prstGeom>
          <a:noFill/>
          <a:ln w="31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764D4258-9E2F-AC42-F399-ED63CA77102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233449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그림 16">
            <a:extLst>
              <a:ext uri="{FF2B5EF4-FFF2-40B4-BE49-F238E27FC236}">
                <a16:creationId xmlns:a16="http://schemas.microsoft.com/office/drawing/2014/main" id="{6956FA2E-72E5-C142-43D5-5FECEFAA53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4563" y="624793"/>
            <a:ext cx="1087794" cy="6123600"/>
          </a:xfrm>
          <a:prstGeom prst="rect">
            <a:avLst/>
          </a:prstGeom>
        </p:spPr>
      </p:pic>
      <p:pic>
        <p:nvPicPr>
          <p:cNvPr id="9" name="그림 8">
            <a:extLst>
              <a:ext uri="{FF2B5EF4-FFF2-40B4-BE49-F238E27FC236}">
                <a16:creationId xmlns:a16="http://schemas.microsoft.com/office/drawing/2014/main" id="{264775BC-68EA-7140-D0F7-ABEF020150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490629" y="624793"/>
            <a:ext cx="1087794" cy="6123600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62406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solidFill>
                  <a:srgbClr val="00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altLang="ko-KR" sz="1200" b="1" dirty="0">
                <a:solidFill>
                  <a:srgbClr val="FF00FF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RFP</a:t>
            </a:r>
            <a:endParaRPr lang="ko-KR" altLang="en-US" sz="1200" b="1" dirty="0">
              <a:solidFill>
                <a:srgbClr val="FF00FF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9" name="직선 연결선 38">
            <a:extLst>
              <a:ext uri="{FF2B5EF4-FFF2-40B4-BE49-F238E27FC236}">
                <a16:creationId xmlns:a16="http://schemas.microsoft.com/office/drawing/2014/main" id="{ECBAD9FC-9F89-446C-8B48-21F3359E9689}"/>
              </a:ext>
            </a:extLst>
          </p:cNvPr>
          <p:cNvCxnSpPr>
            <a:cxnSpLocks/>
          </p:cNvCxnSpPr>
          <p:nvPr/>
        </p:nvCxnSpPr>
        <p:spPr>
          <a:xfrm>
            <a:off x="10370107" y="729111"/>
            <a:ext cx="777600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>
            <a:extLst>
              <a:ext uri="{FF2B5EF4-FFF2-40B4-BE49-F238E27FC236}">
                <a16:creationId xmlns:a16="http://schemas.microsoft.com/office/drawing/2014/main" id="{3DA5514C-7651-A218-45BF-D70CA9FAB257}"/>
              </a:ext>
            </a:extLst>
          </p:cNvPr>
          <p:cNvSpPr txBox="1"/>
          <p:nvPr/>
        </p:nvSpPr>
        <p:spPr>
          <a:xfrm>
            <a:off x="4530526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TAG-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7A2F96E-0AE1-07C0-C488-B9D778C4487E}"/>
              </a:ext>
            </a:extLst>
          </p:cNvPr>
          <p:cNvSpPr txBox="1"/>
          <p:nvPr/>
        </p:nvSpPr>
        <p:spPr>
          <a:xfrm>
            <a:off x="3411591" y="204857"/>
            <a:ext cx="1008000" cy="360000"/>
          </a:xfrm>
          <a:prstGeom prst="rect">
            <a:avLst/>
          </a:prstGeom>
          <a:noFill/>
          <a:ln w="6350">
            <a:solidFill>
              <a:schemeClr val="tx1"/>
            </a:solidFill>
          </a:ln>
        </p:spPr>
        <p:txBody>
          <a:bodyPr wrap="square" rtlCol="0" anchor="ctr">
            <a:normAutofit/>
          </a:bodyPr>
          <a:lstStyle/>
          <a:p>
            <a:pPr algn="ctr"/>
            <a:r>
              <a:rPr lang="en-US" altLang="ko-KR" sz="1000" b="1" dirty="0">
                <a:latin typeface="Arial" panose="020B0604020202020204" pitchFamily="34" charset="0"/>
                <a:cs typeface="Arial" panose="020B0604020202020204" pitchFamily="34" charset="0"/>
              </a:rPr>
              <a:t>H2B Tag-RFP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2409B721-92CF-4A2F-902C-04E5F21B88DC}"/>
              </a:ext>
            </a:extLst>
          </p:cNvPr>
          <p:cNvSpPr txBox="1"/>
          <p:nvPr/>
        </p:nvSpPr>
        <p:spPr>
          <a:xfrm>
            <a:off x="4498849" y="5062417"/>
            <a:ext cx="6286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Upp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E75CD97B-C0BA-4FE0-BF6B-C9BB24E581F6}"/>
              </a:ext>
            </a:extLst>
          </p:cNvPr>
          <p:cNvSpPr txBox="1"/>
          <p:nvPr/>
        </p:nvSpPr>
        <p:spPr>
          <a:xfrm>
            <a:off x="4498849" y="5523877"/>
            <a:ext cx="6383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ower</a:t>
            </a:r>
            <a:endParaRPr lang="ko-KR" altLang="en-US" sz="1200" b="1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6B91C71-B346-D13F-403B-3BB8BD747014}"/>
              </a:ext>
            </a:extLst>
          </p:cNvPr>
          <p:cNvSpPr txBox="1"/>
          <p:nvPr/>
        </p:nvSpPr>
        <p:spPr>
          <a:xfrm>
            <a:off x="0" y="0"/>
            <a:ext cx="19415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anose="020B0604020202020204" pitchFamily="34" charset="0"/>
                <a:cs typeface="Arial" panose="020B0604020202020204" pitchFamily="34" charset="0"/>
              </a:rPr>
              <a:t>E14-E18_p18KD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그림 4">
            <a:extLst>
              <a:ext uri="{FF2B5EF4-FFF2-40B4-BE49-F238E27FC236}">
                <a16:creationId xmlns:a16="http://schemas.microsoft.com/office/drawing/2014/main" id="{C46FE946-93FC-CF50-1F37-E95DBAE3121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86043" y="624793"/>
            <a:ext cx="1087794" cy="6123600"/>
          </a:xfrm>
          <a:prstGeom prst="rect">
            <a:avLst/>
          </a:prstGeom>
        </p:spPr>
      </p:pic>
      <p:sp>
        <p:nvSpPr>
          <p:cNvPr id="12" name="자유형: 도형 11">
            <a:extLst>
              <a:ext uri="{FF2B5EF4-FFF2-40B4-BE49-F238E27FC236}">
                <a16:creationId xmlns:a16="http://schemas.microsoft.com/office/drawing/2014/main" id="{48F12CD7-2EC9-21CA-3B38-E309B9393AFC}"/>
              </a:ext>
            </a:extLst>
          </p:cNvPr>
          <p:cNvSpPr/>
          <p:nvPr/>
        </p:nvSpPr>
        <p:spPr>
          <a:xfrm>
            <a:off x="4488180" y="5364480"/>
            <a:ext cx="1082040" cy="182880"/>
          </a:xfrm>
          <a:custGeom>
            <a:avLst/>
            <a:gdLst>
              <a:gd name="connsiteX0" fmla="*/ 0 w 1082040"/>
              <a:gd name="connsiteY0" fmla="*/ 182880 h 182880"/>
              <a:gd name="connsiteX1" fmla="*/ 68580 w 1082040"/>
              <a:gd name="connsiteY1" fmla="*/ 152400 h 182880"/>
              <a:gd name="connsiteX2" fmla="*/ 121920 w 1082040"/>
              <a:gd name="connsiteY2" fmla="*/ 121920 h 182880"/>
              <a:gd name="connsiteX3" fmla="*/ 190500 w 1082040"/>
              <a:gd name="connsiteY3" fmla="*/ 91440 h 182880"/>
              <a:gd name="connsiteX4" fmla="*/ 297180 w 1082040"/>
              <a:gd name="connsiteY4" fmla="*/ 60960 h 182880"/>
              <a:gd name="connsiteX5" fmla="*/ 320040 w 1082040"/>
              <a:gd name="connsiteY5" fmla="*/ 45720 h 182880"/>
              <a:gd name="connsiteX6" fmla="*/ 365760 w 1082040"/>
              <a:gd name="connsiteY6" fmla="*/ 38100 h 182880"/>
              <a:gd name="connsiteX7" fmla="*/ 502920 w 1082040"/>
              <a:gd name="connsiteY7" fmla="*/ 30480 h 182880"/>
              <a:gd name="connsiteX8" fmla="*/ 609600 w 1082040"/>
              <a:gd name="connsiteY8" fmla="*/ 15240 h 182880"/>
              <a:gd name="connsiteX9" fmla="*/ 784860 w 1082040"/>
              <a:gd name="connsiteY9" fmla="*/ 0 h 182880"/>
              <a:gd name="connsiteX10" fmla="*/ 1059180 w 1082040"/>
              <a:gd name="connsiteY10" fmla="*/ 7620 h 182880"/>
              <a:gd name="connsiteX11" fmla="*/ 1082040 w 1082040"/>
              <a:gd name="connsiteY11" fmla="*/ 15240 h 182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082040" h="182880">
                <a:moveTo>
                  <a:pt x="0" y="182880"/>
                </a:moveTo>
                <a:cubicBezTo>
                  <a:pt x="136272" y="101117"/>
                  <a:pt x="-39336" y="201453"/>
                  <a:pt x="68580" y="152400"/>
                </a:cubicBezTo>
                <a:cubicBezTo>
                  <a:pt x="87223" y="143926"/>
                  <a:pt x="103942" y="131726"/>
                  <a:pt x="121920" y="121920"/>
                </a:cubicBezTo>
                <a:cubicBezTo>
                  <a:pt x="140265" y="111913"/>
                  <a:pt x="171197" y="97231"/>
                  <a:pt x="190500" y="91440"/>
                </a:cubicBezTo>
                <a:cubicBezTo>
                  <a:pt x="229550" y="79725"/>
                  <a:pt x="258506" y="86742"/>
                  <a:pt x="297180" y="60960"/>
                </a:cubicBezTo>
                <a:cubicBezTo>
                  <a:pt x="304800" y="55880"/>
                  <a:pt x="311352" y="48616"/>
                  <a:pt x="320040" y="45720"/>
                </a:cubicBezTo>
                <a:cubicBezTo>
                  <a:pt x="334697" y="40834"/>
                  <a:pt x="350363" y="39383"/>
                  <a:pt x="365760" y="38100"/>
                </a:cubicBezTo>
                <a:cubicBezTo>
                  <a:pt x="411392" y="34297"/>
                  <a:pt x="457200" y="33020"/>
                  <a:pt x="502920" y="30480"/>
                </a:cubicBezTo>
                <a:cubicBezTo>
                  <a:pt x="538480" y="25400"/>
                  <a:pt x="573836" y="18593"/>
                  <a:pt x="609600" y="15240"/>
                </a:cubicBezTo>
                <a:cubicBezTo>
                  <a:pt x="813646" y="-3889"/>
                  <a:pt x="686598" y="19652"/>
                  <a:pt x="784860" y="0"/>
                </a:cubicBezTo>
                <a:cubicBezTo>
                  <a:pt x="876300" y="2540"/>
                  <a:pt x="967825" y="2935"/>
                  <a:pt x="1059180" y="7620"/>
                </a:cubicBezTo>
                <a:cubicBezTo>
                  <a:pt x="1067202" y="8031"/>
                  <a:pt x="1082040" y="15240"/>
                  <a:pt x="1082040" y="1524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13" name="자유형: 도형 12">
            <a:extLst>
              <a:ext uri="{FF2B5EF4-FFF2-40B4-BE49-F238E27FC236}">
                <a16:creationId xmlns:a16="http://schemas.microsoft.com/office/drawing/2014/main" id="{CCDD931B-C6E9-3839-2CE9-AC8656DC1FD8}"/>
              </a:ext>
            </a:extLst>
          </p:cNvPr>
          <p:cNvSpPr/>
          <p:nvPr/>
        </p:nvSpPr>
        <p:spPr>
          <a:xfrm>
            <a:off x="3367457" y="5364480"/>
            <a:ext cx="1082040" cy="182880"/>
          </a:xfrm>
          <a:custGeom>
            <a:avLst/>
            <a:gdLst>
              <a:gd name="connsiteX0" fmla="*/ 0 w 1082040"/>
              <a:gd name="connsiteY0" fmla="*/ 182880 h 182880"/>
              <a:gd name="connsiteX1" fmla="*/ 68580 w 1082040"/>
              <a:gd name="connsiteY1" fmla="*/ 152400 h 182880"/>
              <a:gd name="connsiteX2" fmla="*/ 121920 w 1082040"/>
              <a:gd name="connsiteY2" fmla="*/ 121920 h 182880"/>
              <a:gd name="connsiteX3" fmla="*/ 190500 w 1082040"/>
              <a:gd name="connsiteY3" fmla="*/ 91440 h 182880"/>
              <a:gd name="connsiteX4" fmla="*/ 297180 w 1082040"/>
              <a:gd name="connsiteY4" fmla="*/ 60960 h 182880"/>
              <a:gd name="connsiteX5" fmla="*/ 320040 w 1082040"/>
              <a:gd name="connsiteY5" fmla="*/ 45720 h 182880"/>
              <a:gd name="connsiteX6" fmla="*/ 365760 w 1082040"/>
              <a:gd name="connsiteY6" fmla="*/ 38100 h 182880"/>
              <a:gd name="connsiteX7" fmla="*/ 502920 w 1082040"/>
              <a:gd name="connsiteY7" fmla="*/ 30480 h 182880"/>
              <a:gd name="connsiteX8" fmla="*/ 609600 w 1082040"/>
              <a:gd name="connsiteY8" fmla="*/ 15240 h 182880"/>
              <a:gd name="connsiteX9" fmla="*/ 784860 w 1082040"/>
              <a:gd name="connsiteY9" fmla="*/ 0 h 182880"/>
              <a:gd name="connsiteX10" fmla="*/ 1059180 w 1082040"/>
              <a:gd name="connsiteY10" fmla="*/ 7620 h 182880"/>
              <a:gd name="connsiteX11" fmla="*/ 1082040 w 1082040"/>
              <a:gd name="connsiteY11" fmla="*/ 15240 h 18288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1082040" h="182880">
                <a:moveTo>
                  <a:pt x="0" y="182880"/>
                </a:moveTo>
                <a:cubicBezTo>
                  <a:pt x="136272" y="101117"/>
                  <a:pt x="-39336" y="201453"/>
                  <a:pt x="68580" y="152400"/>
                </a:cubicBezTo>
                <a:cubicBezTo>
                  <a:pt x="87223" y="143926"/>
                  <a:pt x="103942" y="131726"/>
                  <a:pt x="121920" y="121920"/>
                </a:cubicBezTo>
                <a:cubicBezTo>
                  <a:pt x="140265" y="111913"/>
                  <a:pt x="171197" y="97231"/>
                  <a:pt x="190500" y="91440"/>
                </a:cubicBezTo>
                <a:cubicBezTo>
                  <a:pt x="229550" y="79725"/>
                  <a:pt x="258506" y="86742"/>
                  <a:pt x="297180" y="60960"/>
                </a:cubicBezTo>
                <a:cubicBezTo>
                  <a:pt x="304800" y="55880"/>
                  <a:pt x="311352" y="48616"/>
                  <a:pt x="320040" y="45720"/>
                </a:cubicBezTo>
                <a:cubicBezTo>
                  <a:pt x="334697" y="40834"/>
                  <a:pt x="350363" y="39383"/>
                  <a:pt x="365760" y="38100"/>
                </a:cubicBezTo>
                <a:cubicBezTo>
                  <a:pt x="411392" y="34297"/>
                  <a:pt x="457200" y="33020"/>
                  <a:pt x="502920" y="30480"/>
                </a:cubicBezTo>
                <a:cubicBezTo>
                  <a:pt x="538480" y="25400"/>
                  <a:pt x="573836" y="18593"/>
                  <a:pt x="609600" y="15240"/>
                </a:cubicBezTo>
                <a:cubicBezTo>
                  <a:pt x="813646" y="-3889"/>
                  <a:pt x="686598" y="19652"/>
                  <a:pt x="784860" y="0"/>
                </a:cubicBezTo>
                <a:cubicBezTo>
                  <a:pt x="876300" y="2540"/>
                  <a:pt x="967825" y="2935"/>
                  <a:pt x="1059180" y="7620"/>
                </a:cubicBezTo>
                <a:cubicBezTo>
                  <a:pt x="1067202" y="8031"/>
                  <a:pt x="1082040" y="15240"/>
                  <a:pt x="1082040" y="15240"/>
                </a:cubicBezTo>
              </a:path>
            </a:pathLst>
          </a:custGeom>
          <a:noFill/>
          <a:ln w="19050">
            <a:solidFill>
              <a:srgbClr val="FFFF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67452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89</Words>
  <Application>Microsoft Office PowerPoint</Application>
  <PresentationFormat>와이드스크린</PresentationFormat>
  <Paragraphs>44</Paragraphs>
  <Slides>1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4</vt:i4>
      </vt:variant>
    </vt:vector>
  </HeadingPairs>
  <TitlesOfParts>
    <vt:vector size="17" baseType="lpstr">
      <vt:lpstr>맑은 고딕</vt:lpstr>
      <vt:lpstr>Arial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이 원영</dc:creator>
  <cp:lastModifiedBy>이 원영</cp:lastModifiedBy>
  <cp:revision>11</cp:revision>
  <dcterms:created xsi:type="dcterms:W3CDTF">2019-08-22T05:43:38Z</dcterms:created>
  <dcterms:modified xsi:type="dcterms:W3CDTF">2023-02-16T05:51:30Z</dcterms:modified>
</cp:coreProperties>
</file>